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0801350" cy="7200900"/>
  <p:notesSz cx="6858000" cy="9144000"/>
  <p:defaultTextStyle>
    <a:defPPr>
      <a:defRPr lang="es-MX"/>
    </a:defPPr>
    <a:lvl1pPr marL="0" algn="l" defTabSz="1107719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553860" algn="l" defTabSz="1107719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107719" algn="l" defTabSz="1107719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1661580" algn="l" defTabSz="1107719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2215440" algn="l" defTabSz="1107719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2769299" algn="l" defTabSz="1107719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3323159" algn="l" defTabSz="1107719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3877020" algn="l" defTabSz="1107719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4430879" algn="l" defTabSz="1107719" rtl="0" eaLnBrk="1" latinLnBrk="0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89" d="100"/>
          <a:sy n="89" d="100"/>
        </p:scale>
        <p:origin x="-300" y="1260"/>
      </p:cViewPr>
      <p:guideLst>
        <p:guide orient="horz" pos="1814"/>
        <p:guide pos="6486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&amp;M\Desktop\proyecto%20PSEUDOMONAS\POSDOC\CURCUMINA\Dratf%20paper\Images\FIGURES%20CURCUMA\Figure%203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&amp;M\Desktop\proyecto%20PSEUDOMONAS\POSDOC\CURCUMINA\Dratf%20paper\Images\FIGURES%20CURCUMA\Figura%203D.%20Biofilm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M&amp;M\Desktop\proyecto%20PSEUDOMONAS\POSDOC\CURCUMINA\Dratf%20paper\Images\FIGURES%20CURCUMA\Figure%203C.%20Caseinolytic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MX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0434951881014873"/>
          <c:y val="2.5867964421114026E-2"/>
          <c:w val="0.76509492563429571"/>
          <c:h val="0.7212864537766112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Piover 1 a 100'!$C$23</c:f>
              <c:strCache>
                <c:ptCount val="1"/>
                <c:pt idx="0">
                  <c:v>LB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cat>
            <c:strRef>
              <c:f>'Piover 1 a 100'!$B$24:$B$29</c:f>
              <c:strCache>
                <c:ptCount val="6"/>
                <c:pt idx="0">
                  <c:v>PAO 1 Wt</c:v>
                </c:pt>
                <c:pt idx="1">
                  <c:v>PA14 Wt</c:v>
                </c:pt>
                <c:pt idx="2">
                  <c:v>INP-30R</c:v>
                </c:pt>
                <c:pt idx="3">
                  <c:v>INP-4O</c:v>
                </c:pt>
                <c:pt idx="4">
                  <c:v>P044</c:v>
                </c:pt>
                <c:pt idx="5">
                  <c:v>P076</c:v>
                </c:pt>
              </c:strCache>
            </c:strRef>
          </c:cat>
          <c:val>
            <c:numRef>
              <c:f>'Piover 1 a 100'!$C$24:$C$29</c:f>
              <c:numCache>
                <c:formatCode>General</c:formatCode>
                <c:ptCount val="6"/>
                <c:pt idx="0">
                  <c:v>74782.39</c:v>
                </c:pt>
                <c:pt idx="1">
                  <c:v>63746.29</c:v>
                </c:pt>
                <c:pt idx="2">
                  <c:v>88137.3</c:v>
                </c:pt>
                <c:pt idx="3">
                  <c:v>69285.83</c:v>
                </c:pt>
                <c:pt idx="4">
                  <c:v>141276.28</c:v>
                </c:pt>
                <c:pt idx="5">
                  <c:v>74143.56</c:v>
                </c:pt>
              </c:numCache>
            </c:numRef>
          </c:val>
        </c:ser>
        <c:ser>
          <c:idx val="1"/>
          <c:order val="1"/>
          <c:tx>
            <c:strRef>
              <c:f>'Piover 1 a 100'!$D$23</c:f>
              <c:strCache>
                <c:ptCount val="1"/>
                <c:pt idx="0">
                  <c:v>Curcumin 50 μM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cat>
            <c:strRef>
              <c:f>'Piover 1 a 100'!$B$24:$B$29</c:f>
              <c:strCache>
                <c:ptCount val="6"/>
                <c:pt idx="0">
                  <c:v>PAO 1 Wt</c:v>
                </c:pt>
                <c:pt idx="1">
                  <c:v>PA14 Wt</c:v>
                </c:pt>
                <c:pt idx="2">
                  <c:v>INP-30R</c:v>
                </c:pt>
                <c:pt idx="3">
                  <c:v>INP-4O</c:v>
                </c:pt>
                <c:pt idx="4">
                  <c:v>P044</c:v>
                </c:pt>
                <c:pt idx="5">
                  <c:v>P076</c:v>
                </c:pt>
              </c:strCache>
            </c:strRef>
          </c:cat>
          <c:val>
            <c:numRef>
              <c:f>'Piover 1 a 100'!$D$24:$D$29</c:f>
              <c:numCache>
                <c:formatCode>General</c:formatCode>
                <c:ptCount val="6"/>
                <c:pt idx="0">
                  <c:v>19443.13</c:v>
                </c:pt>
                <c:pt idx="1">
                  <c:v>25991.41</c:v>
                </c:pt>
                <c:pt idx="2">
                  <c:v>27007.439999999999</c:v>
                </c:pt>
                <c:pt idx="3">
                  <c:v>13426.42</c:v>
                </c:pt>
                <c:pt idx="4">
                  <c:v>8047.58</c:v>
                </c:pt>
                <c:pt idx="5">
                  <c:v>12630.2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36528640"/>
        <c:axId val="158184576"/>
      </c:barChart>
      <c:catAx>
        <c:axId val="136528640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 rot="-1800000"/>
          <a:lstStyle/>
          <a:p>
            <a:pPr>
              <a:defRPr sz="1200"/>
            </a:pPr>
            <a:endParaRPr lang="es-MX"/>
          </a:p>
        </c:txPr>
        <c:crossAx val="158184576"/>
        <c:crosses val="autoZero"/>
        <c:auto val="1"/>
        <c:lblAlgn val="ctr"/>
        <c:lblOffset val="100"/>
        <c:noMultiLvlLbl val="0"/>
      </c:catAx>
      <c:valAx>
        <c:axId val="158184576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s-MX" sz="1400" dirty="0" err="1"/>
                  <a:t>Pyoverdine</a:t>
                </a:r>
                <a:endParaRPr lang="es-MX" sz="140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3652864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s-MX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MX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Figura 3C'!$F$24</c:f>
              <c:strCache>
                <c:ptCount val="1"/>
                <c:pt idx="0">
                  <c:v>LB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cat>
            <c:strRef>
              <c:f>'Figura 3C'!$E$25:$E$30</c:f>
              <c:strCache>
                <c:ptCount val="6"/>
                <c:pt idx="0">
                  <c:v>PA14</c:v>
                </c:pt>
                <c:pt idx="1">
                  <c:v>PAO1</c:v>
                </c:pt>
                <c:pt idx="2">
                  <c:v>INP-30</c:v>
                </c:pt>
                <c:pt idx="3">
                  <c:v>INP-40</c:v>
                </c:pt>
                <c:pt idx="4">
                  <c:v>P044</c:v>
                </c:pt>
                <c:pt idx="5">
                  <c:v>P076</c:v>
                </c:pt>
              </c:strCache>
            </c:strRef>
          </c:cat>
          <c:val>
            <c:numRef>
              <c:f>'Figura 3C'!$F$25:$F$30</c:f>
              <c:numCache>
                <c:formatCode>General</c:formatCode>
                <c:ptCount val="6"/>
                <c:pt idx="0">
                  <c:v>0.44</c:v>
                </c:pt>
                <c:pt idx="1">
                  <c:v>0.5</c:v>
                </c:pt>
                <c:pt idx="2">
                  <c:v>0.36</c:v>
                </c:pt>
                <c:pt idx="3">
                  <c:v>0.16</c:v>
                </c:pt>
                <c:pt idx="4">
                  <c:v>0.14000000000000001</c:v>
                </c:pt>
                <c:pt idx="5">
                  <c:v>0.36</c:v>
                </c:pt>
              </c:numCache>
            </c:numRef>
          </c:val>
        </c:ser>
        <c:ser>
          <c:idx val="1"/>
          <c:order val="1"/>
          <c:tx>
            <c:strRef>
              <c:f>'Figura 3C'!$G$24</c:f>
              <c:strCache>
                <c:ptCount val="1"/>
                <c:pt idx="0">
                  <c:v>50 μM Curcuma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cat>
            <c:strRef>
              <c:f>'Figura 3C'!$E$25:$E$30</c:f>
              <c:strCache>
                <c:ptCount val="6"/>
                <c:pt idx="0">
                  <c:v>PA14</c:v>
                </c:pt>
                <c:pt idx="1">
                  <c:v>PAO1</c:v>
                </c:pt>
                <c:pt idx="2">
                  <c:v>INP-30</c:v>
                </c:pt>
                <c:pt idx="3">
                  <c:v>INP-40</c:v>
                </c:pt>
                <c:pt idx="4">
                  <c:v>P044</c:v>
                </c:pt>
                <c:pt idx="5">
                  <c:v>P076</c:v>
                </c:pt>
              </c:strCache>
            </c:strRef>
          </c:cat>
          <c:val>
            <c:numRef>
              <c:f>'Figura 3C'!$G$25:$G$30</c:f>
              <c:numCache>
                <c:formatCode>General</c:formatCode>
                <c:ptCount val="6"/>
                <c:pt idx="0">
                  <c:v>0.34</c:v>
                </c:pt>
                <c:pt idx="1">
                  <c:v>0.33</c:v>
                </c:pt>
                <c:pt idx="2">
                  <c:v>0.23</c:v>
                </c:pt>
                <c:pt idx="3">
                  <c:v>0.11</c:v>
                </c:pt>
                <c:pt idx="4">
                  <c:v>0.15</c:v>
                </c:pt>
                <c:pt idx="5">
                  <c:v>0.1400000000000000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300"/>
        <c:axId val="141774848"/>
        <c:axId val="141776768"/>
      </c:barChart>
      <c:catAx>
        <c:axId val="141774848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 rot="-1800000"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MX"/>
          </a:p>
        </c:txPr>
        <c:crossAx val="141776768"/>
        <c:crosses val="autoZero"/>
        <c:auto val="1"/>
        <c:lblAlgn val="ctr"/>
        <c:lblOffset val="100"/>
        <c:noMultiLvlLbl val="0"/>
      </c:catAx>
      <c:valAx>
        <c:axId val="141776768"/>
        <c:scaling>
          <c:orientation val="minMax"/>
          <c:max val="0.55000000000000004"/>
        </c:scaling>
        <c:delete val="0"/>
        <c:axPos val="l"/>
        <c:title>
          <c:tx>
            <c:rich>
              <a:bodyPr/>
              <a:lstStyle/>
              <a:p>
                <a:pPr>
                  <a:defRPr sz="14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s-MX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Biofilm</a:t>
                </a:r>
                <a:r>
                  <a:rPr lang="es-MX" sz="1400" baseline="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MX" sz="1400" baseline="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formation</a:t>
                </a:r>
                <a:endParaRPr lang="es-MX" sz="1400" baseline="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s-MX"/>
          </a:p>
        </c:txPr>
        <c:crossAx val="14177484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MX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Caseinolytic!$B$38</c:f>
              <c:strCache>
                <c:ptCount val="1"/>
                <c:pt idx="0">
                  <c:v>No curcumina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invertIfNegative val="0"/>
          <c:cat>
            <c:strRef>
              <c:f>Caseinolytic!$A$39:$A$44</c:f>
              <c:strCache>
                <c:ptCount val="6"/>
                <c:pt idx="0">
                  <c:v>PAO 1 WT</c:v>
                </c:pt>
                <c:pt idx="1">
                  <c:v>PA14 WT</c:v>
                </c:pt>
                <c:pt idx="2">
                  <c:v>INP-30R </c:v>
                </c:pt>
                <c:pt idx="3">
                  <c:v>INP-40 </c:v>
                </c:pt>
                <c:pt idx="4">
                  <c:v>P044 </c:v>
                </c:pt>
                <c:pt idx="5">
                  <c:v>P076 </c:v>
                </c:pt>
              </c:strCache>
            </c:strRef>
          </c:cat>
          <c:val>
            <c:numRef>
              <c:f>Caseinolytic!$B$39:$B$44</c:f>
              <c:numCache>
                <c:formatCode>General</c:formatCode>
                <c:ptCount val="6"/>
                <c:pt idx="0">
                  <c:v>1.2212255444813584</c:v>
                </c:pt>
                <c:pt idx="1">
                  <c:v>1.3845076060848678</c:v>
                </c:pt>
                <c:pt idx="2">
                  <c:v>7.4342629482071723E-2</c:v>
                </c:pt>
                <c:pt idx="3">
                  <c:v>2.13957375679064E-2</c:v>
                </c:pt>
                <c:pt idx="4">
                  <c:v>9.503637141634573E-2</c:v>
                </c:pt>
                <c:pt idx="5">
                  <c:v>3.8709677419354854E-2</c:v>
                </c:pt>
              </c:numCache>
            </c:numRef>
          </c:val>
        </c:ser>
        <c:ser>
          <c:idx val="1"/>
          <c:order val="1"/>
          <c:tx>
            <c:strRef>
              <c:f>Caseinolytic!$C$38</c:f>
              <c:strCache>
                <c:ptCount val="1"/>
                <c:pt idx="0">
                  <c:v>50 μM curcuma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50000"/>
                </a:schemeClr>
              </a:solidFill>
            </a:ln>
          </c:spPr>
          <c:invertIfNegative val="0"/>
          <c:cat>
            <c:strRef>
              <c:f>Caseinolytic!$A$39:$A$44</c:f>
              <c:strCache>
                <c:ptCount val="6"/>
                <c:pt idx="0">
                  <c:v>PAO 1 WT</c:v>
                </c:pt>
                <c:pt idx="1">
                  <c:v>PA14 WT</c:v>
                </c:pt>
                <c:pt idx="2">
                  <c:v>INP-30R </c:v>
                </c:pt>
                <c:pt idx="3">
                  <c:v>INP-40 </c:v>
                </c:pt>
                <c:pt idx="4">
                  <c:v>P044 </c:v>
                </c:pt>
                <c:pt idx="5">
                  <c:v>P076 </c:v>
                </c:pt>
              </c:strCache>
            </c:strRef>
          </c:cat>
          <c:val>
            <c:numRef>
              <c:f>Caseinolytic!$C$39:$C$44</c:f>
              <c:numCache>
                <c:formatCode>General</c:formatCode>
                <c:ptCount val="6"/>
                <c:pt idx="0">
                  <c:v>0.96764346764346765</c:v>
                </c:pt>
                <c:pt idx="1">
                  <c:v>1.140746819860484</c:v>
                </c:pt>
                <c:pt idx="2">
                  <c:v>9.6260786193672079E-2</c:v>
                </c:pt>
                <c:pt idx="3">
                  <c:v>0</c:v>
                </c:pt>
                <c:pt idx="4">
                  <c:v>0.45635052689961164</c:v>
                </c:pt>
                <c:pt idx="5">
                  <c:v>1.5133531157270032E-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58316800"/>
        <c:axId val="159216000"/>
      </c:barChart>
      <c:catAx>
        <c:axId val="158316800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 rot="-1800000"/>
          <a:lstStyle/>
          <a:p>
            <a:pPr>
              <a:defRPr sz="1200"/>
            </a:pPr>
            <a:endParaRPr lang="es-MX"/>
          </a:p>
        </c:txPr>
        <c:crossAx val="159216000"/>
        <c:crosses val="autoZero"/>
        <c:auto val="1"/>
        <c:lblAlgn val="ctr"/>
        <c:lblOffset val="100"/>
        <c:noMultiLvlLbl val="0"/>
      </c:catAx>
      <c:valAx>
        <c:axId val="159216000"/>
        <c:scaling>
          <c:orientation val="minMax"/>
          <c:max val="1.5"/>
        </c:scaling>
        <c:delete val="0"/>
        <c:axPos val="l"/>
        <c:title>
          <c:tx>
            <c:rich>
              <a:bodyPr/>
              <a:lstStyle/>
              <a:p>
                <a:pPr>
                  <a:defRPr sz="1400"/>
                </a:pPr>
                <a:r>
                  <a:rPr lang="es-MX" sz="1400"/>
                  <a:t>Caseinolytic  activity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5831680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s-MX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810102" y="2236948"/>
            <a:ext cx="9181148" cy="1543527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620203" y="4080510"/>
            <a:ext cx="7560945" cy="184023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538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1077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615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2154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76929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3231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8770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43087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C9766-C842-4B0D-A77D-2252894A4EDD}" type="datetimeFigureOut">
              <a:rPr lang="es-MX" smtClean="0"/>
              <a:t>18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3EF0A-99CA-4F1A-A65B-FD8D66C10D0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832867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C9766-C842-4B0D-A77D-2252894A4EDD}" type="datetimeFigureOut">
              <a:rPr lang="es-MX" smtClean="0"/>
              <a:t>18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3EF0A-99CA-4F1A-A65B-FD8D66C10D0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176702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7830980" y="288371"/>
            <a:ext cx="2430304" cy="6144101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540067" y="288371"/>
            <a:ext cx="7110889" cy="6144101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C9766-C842-4B0D-A77D-2252894A4EDD}" type="datetimeFigureOut">
              <a:rPr lang="es-MX" smtClean="0"/>
              <a:t>18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3EF0A-99CA-4F1A-A65B-FD8D66C10D0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739020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C9766-C842-4B0D-A77D-2252894A4EDD}" type="datetimeFigureOut">
              <a:rPr lang="es-MX" smtClean="0"/>
              <a:t>18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3EF0A-99CA-4F1A-A65B-FD8D66C10D0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9091436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853233" y="4627246"/>
            <a:ext cx="9181148" cy="1430179"/>
          </a:xfrm>
        </p:spPr>
        <p:txBody>
          <a:bodyPr anchor="t"/>
          <a:lstStyle>
            <a:lvl1pPr algn="l">
              <a:defRPr sz="49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853233" y="3052049"/>
            <a:ext cx="9181148" cy="1575197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538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10771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3pPr>
            <a:lvl4pPr marL="166158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21544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769299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323159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8770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430879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C9766-C842-4B0D-A77D-2252894A4EDD}" type="datetimeFigureOut">
              <a:rPr lang="es-MX" smtClean="0"/>
              <a:t>18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3EF0A-99CA-4F1A-A65B-FD8D66C10D0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8630922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540069" y="1680212"/>
            <a:ext cx="4770596" cy="4752261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490688" y="1680212"/>
            <a:ext cx="4770596" cy="4752261"/>
          </a:xfrm>
        </p:spPr>
        <p:txBody>
          <a:bodyPr/>
          <a:lstStyle>
            <a:lvl1pPr>
              <a:defRPr sz="3400"/>
            </a:lvl1pPr>
            <a:lvl2pPr>
              <a:defRPr sz="2900"/>
            </a:lvl2pPr>
            <a:lvl3pPr>
              <a:defRPr sz="24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C9766-C842-4B0D-A77D-2252894A4EDD}" type="datetimeFigureOut">
              <a:rPr lang="es-MX" smtClean="0"/>
              <a:t>18/12/2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3EF0A-99CA-4F1A-A65B-FD8D66C10D0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9029500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0068" y="1611869"/>
            <a:ext cx="4772472" cy="671751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53860" indent="0">
              <a:buNone/>
              <a:defRPr sz="2400" b="1"/>
            </a:lvl2pPr>
            <a:lvl3pPr marL="1107719" indent="0">
              <a:buNone/>
              <a:defRPr sz="2200" b="1"/>
            </a:lvl3pPr>
            <a:lvl4pPr marL="1661580" indent="0">
              <a:buNone/>
              <a:defRPr sz="2000" b="1"/>
            </a:lvl4pPr>
            <a:lvl5pPr marL="2215440" indent="0">
              <a:buNone/>
              <a:defRPr sz="2000" b="1"/>
            </a:lvl5pPr>
            <a:lvl6pPr marL="2769299" indent="0">
              <a:buNone/>
              <a:defRPr sz="2000" b="1"/>
            </a:lvl6pPr>
            <a:lvl7pPr marL="3323159" indent="0">
              <a:buNone/>
              <a:defRPr sz="2000" b="1"/>
            </a:lvl7pPr>
            <a:lvl8pPr marL="3877020" indent="0">
              <a:buNone/>
              <a:defRPr sz="2000" b="1"/>
            </a:lvl8pPr>
            <a:lvl9pPr marL="4430879" indent="0">
              <a:buNone/>
              <a:defRPr sz="20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540068" y="2283620"/>
            <a:ext cx="4772472" cy="4148852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5486938" y="1611869"/>
            <a:ext cx="4774347" cy="671751"/>
          </a:xfrm>
        </p:spPr>
        <p:txBody>
          <a:bodyPr anchor="b"/>
          <a:lstStyle>
            <a:lvl1pPr marL="0" indent="0">
              <a:buNone/>
              <a:defRPr sz="2900" b="1"/>
            </a:lvl1pPr>
            <a:lvl2pPr marL="553860" indent="0">
              <a:buNone/>
              <a:defRPr sz="2400" b="1"/>
            </a:lvl2pPr>
            <a:lvl3pPr marL="1107719" indent="0">
              <a:buNone/>
              <a:defRPr sz="2200" b="1"/>
            </a:lvl3pPr>
            <a:lvl4pPr marL="1661580" indent="0">
              <a:buNone/>
              <a:defRPr sz="2000" b="1"/>
            </a:lvl4pPr>
            <a:lvl5pPr marL="2215440" indent="0">
              <a:buNone/>
              <a:defRPr sz="2000" b="1"/>
            </a:lvl5pPr>
            <a:lvl6pPr marL="2769299" indent="0">
              <a:buNone/>
              <a:defRPr sz="2000" b="1"/>
            </a:lvl6pPr>
            <a:lvl7pPr marL="3323159" indent="0">
              <a:buNone/>
              <a:defRPr sz="2000" b="1"/>
            </a:lvl7pPr>
            <a:lvl8pPr marL="3877020" indent="0">
              <a:buNone/>
              <a:defRPr sz="2000" b="1"/>
            </a:lvl8pPr>
            <a:lvl9pPr marL="4430879" indent="0">
              <a:buNone/>
              <a:defRPr sz="20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5486938" y="2283620"/>
            <a:ext cx="4774347" cy="4148852"/>
          </a:xfrm>
        </p:spPr>
        <p:txBody>
          <a:bodyPr/>
          <a:lstStyle>
            <a:lvl1pPr>
              <a:defRPr sz="2900"/>
            </a:lvl1pPr>
            <a:lvl2pPr>
              <a:defRPr sz="2400"/>
            </a:lvl2pPr>
            <a:lvl3pPr>
              <a:defRPr sz="22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C9766-C842-4B0D-A77D-2252894A4EDD}" type="datetimeFigureOut">
              <a:rPr lang="es-MX" smtClean="0"/>
              <a:t>18/12/23</a:t>
            </a:fld>
            <a:endParaRPr lang="es-MX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3EF0A-99CA-4F1A-A65B-FD8D66C10D0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0653882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C9766-C842-4B0D-A77D-2252894A4EDD}" type="datetimeFigureOut">
              <a:rPr lang="es-MX" smtClean="0"/>
              <a:t>18/12/23</a:t>
            </a:fld>
            <a:endParaRPr lang="es-MX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3EF0A-99CA-4F1A-A65B-FD8D66C10D0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6308054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C9766-C842-4B0D-A77D-2252894A4EDD}" type="datetimeFigureOut">
              <a:rPr lang="es-MX" smtClean="0"/>
              <a:t>18/12/23</a:t>
            </a:fld>
            <a:endParaRPr lang="es-MX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3EF0A-99CA-4F1A-A65B-FD8D66C10D0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2049199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0071" y="286702"/>
            <a:ext cx="3553570" cy="1220153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4223028" y="286705"/>
            <a:ext cx="6038255" cy="6145768"/>
          </a:xfrm>
        </p:spPr>
        <p:txBody>
          <a:bodyPr/>
          <a:lstStyle>
            <a:lvl1pPr>
              <a:defRPr sz="3800"/>
            </a:lvl1pPr>
            <a:lvl2pPr>
              <a:defRPr sz="3400"/>
            </a:lvl2pPr>
            <a:lvl3pPr>
              <a:defRPr sz="29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540071" y="1506858"/>
            <a:ext cx="3553570" cy="4925616"/>
          </a:xfrm>
        </p:spPr>
        <p:txBody>
          <a:bodyPr/>
          <a:lstStyle>
            <a:lvl1pPr marL="0" indent="0">
              <a:buNone/>
              <a:defRPr sz="1700"/>
            </a:lvl1pPr>
            <a:lvl2pPr marL="553860" indent="0">
              <a:buNone/>
              <a:defRPr sz="1500"/>
            </a:lvl2pPr>
            <a:lvl3pPr marL="1107719" indent="0">
              <a:buNone/>
              <a:defRPr sz="1200"/>
            </a:lvl3pPr>
            <a:lvl4pPr marL="1661580" indent="0">
              <a:buNone/>
              <a:defRPr sz="1000"/>
            </a:lvl4pPr>
            <a:lvl5pPr marL="2215440" indent="0">
              <a:buNone/>
              <a:defRPr sz="1000"/>
            </a:lvl5pPr>
            <a:lvl6pPr marL="2769299" indent="0">
              <a:buNone/>
              <a:defRPr sz="1000"/>
            </a:lvl6pPr>
            <a:lvl7pPr marL="3323159" indent="0">
              <a:buNone/>
              <a:defRPr sz="1000"/>
            </a:lvl7pPr>
            <a:lvl8pPr marL="3877020" indent="0">
              <a:buNone/>
              <a:defRPr sz="1000"/>
            </a:lvl8pPr>
            <a:lvl9pPr marL="4430879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C9766-C842-4B0D-A77D-2252894A4EDD}" type="datetimeFigureOut">
              <a:rPr lang="es-MX" smtClean="0"/>
              <a:t>18/12/2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3EF0A-99CA-4F1A-A65B-FD8D66C10D0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35962522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2117141" y="5040630"/>
            <a:ext cx="6480810" cy="595075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2117141" y="643414"/>
            <a:ext cx="6480810" cy="4320540"/>
          </a:xfrm>
        </p:spPr>
        <p:txBody>
          <a:bodyPr/>
          <a:lstStyle>
            <a:lvl1pPr marL="0" indent="0">
              <a:buNone/>
              <a:defRPr sz="3800"/>
            </a:lvl1pPr>
            <a:lvl2pPr marL="553860" indent="0">
              <a:buNone/>
              <a:defRPr sz="3400"/>
            </a:lvl2pPr>
            <a:lvl3pPr marL="1107719" indent="0">
              <a:buNone/>
              <a:defRPr sz="2900"/>
            </a:lvl3pPr>
            <a:lvl4pPr marL="1661580" indent="0">
              <a:buNone/>
              <a:defRPr sz="2400"/>
            </a:lvl4pPr>
            <a:lvl5pPr marL="2215440" indent="0">
              <a:buNone/>
              <a:defRPr sz="2400"/>
            </a:lvl5pPr>
            <a:lvl6pPr marL="2769299" indent="0">
              <a:buNone/>
              <a:defRPr sz="2400"/>
            </a:lvl6pPr>
            <a:lvl7pPr marL="3323159" indent="0">
              <a:buNone/>
              <a:defRPr sz="2400"/>
            </a:lvl7pPr>
            <a:lvl8pPr marL="3877020" indent="0">
              <a:buNone/>
              <a:defRPr sz="2400"/>
            </a:lvl8pPr>
            <a:lvl9pPr marL="4430879" indent="0">
              <a:buNone/>
              <a:defRPr sz="2400"/>
            </a:lvl9pPr>
          </a:lstStyle>
          <a:p>
            <a:endParaRPr lang="es-MX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2117141" y="5635707"/>
            <a:ext cx="6480810" cy="845106"/>
          </a:xfrm>
        </p:spPr>
        <p:txBody>
          <a:bodyPr/>
          <a:lstStyle>
            <a:lvl1pPr marL="0" indent="0">
              <a:buNone/>
              <a:defRPr sz="1700"/>
            </a:lvl1pPr>
            <a:lvl2pPr marL="553860" indent="0">
              <a:buNone/>
              <a:defRPr sz="1500"/>
            </a:lvl2pPr>
            <a:lvl3pPr marL="1107719" indent="0">
              <a:buNone/>
              <a:defRPr sz="1200"/>
            </a:lvl3pPr>
            <a:lvl4pPr marL="1661580" indent="0">
              <a:buNone/>
              <a:defRPr sz="1000"/>
            </a:lvl4pPr>
            <a:lvl5pPr marL="2215440" indent="0">
              <a:buNone/>
              <a:defRPr sz="1000"/>
            </a:lvl5pPr>
            <a:lvl6pPr marL="2769299" indent="0">
              <a:buNone/>
              <a:defRPr sz="1000"/>
            </a:lvl6pPr>
            <a:lvl7pPr marL="3323159" indent="0">
              <a:buNone/>
              <a:defRPr sz="1000"/>
            </a:lvl7pPr>
            <a:lvl8pPr marL="3877020" indent="0">
              <a:buNone/>
              <a:defRPr sz="1000"/>
            </a:lvl8pPr>
            <a:lvl9pPr marL="4430879" indent="0">
              <a:buNone/>
              <a:defRPr sz="1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CFC9766-C842-4B0D-A77D-2252894A4EDD}" type="datetimeFigureOut">
              <a:rPr lang="es-MX" smtClean="0"/>
              <a:t>18/12/23</a:t>
            </a:fld>
            <a:endParaRPr lang="es-MX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MX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53EF0A-99CA-4F1A-A65B-FD8D66C10D0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293346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540069" y="288372"/>
            <a:ext cx="9721215" cy="1200150"/>
          </a:xfrm>
          <a:prstGeom prst="rect">
            <a:avLst/>
          </a:prstGeom>
        </p:spPr>
        <p:txBody>
          <a:bodyPr vert="horz" lIns="110772" tIns="55386" rIns="110772" bIns="55386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MX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0069" y="1680212"/>
            <a:ext cx="9721215" cy="4752261"/>
          </a:xfrm>
          <a:prstGeom prst="rect">
            <a:avLst/>
          </a:prstGeom>
        </p:spPr>
        <p:txBody>
          <a:bodyPr vert="horz" lIns="110772" tIns="55386" rIns="110772" bIns="55386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MX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540069" y="6674169"/>
            <a:ext cx="2520315" cy="383381"/>
          </a:xfrm>
          <a:prstGeom prst="rect">
            <a:avLst/>
          </a:prstGeom>
        </p:spPr>
        <p:txBody>
          <a:bodyPr vert="horz" lIns="110772" tIns="55386" rIns="110772" bIns="55386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CFC9766-C842-4B0D-A77D-2252894A4EDD}" type="datetimeFigureOut">
              <a:rPr lang="es-MX" smtClean="0"/>
              <a:t>18/12/23</a:t>
            </a:fld>
            <a:endParaRPr lang="es-MX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690463" y="6674169"/>
            <a:ext cx="3420427" cy="383381"/>
          </a:xfrm>
          <a:prstGeom prst="rect">
            <a:avLst/>
          </a:prstGeom>
        </p:spPr>
        <p:txBody>
          <a:bodyPr vert="horz" lIns="110772" tIns="55386" rIns="110772" bIns="55386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MX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7740969" y="6674169"/>
            <a:ext cx="2520315" cy="383381"/>
          </a:xfrm>
          <a:prstGeom prst="rect">
            <a:avLst/>
          </a:prstGeom>
        </p:spPr>
        <p:txBody>
          <a:bodyPr vert="horz" lIns="110772" tIns="55386" rIns="110772" bIns="55386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53EF0A-99CA-4F1A-A65B-FD8D66C10D0D}" type="slidenum">
              <a:rPr lang="es-MX" smtClean="0"/>
              <a:t>‹Nº›</a:t>
            </a:fld>
            <a:endParaRPr lang="es-MX"/>
          </a:p>
        </p:txBody>
      </p:sp>
    </p:spTree>
    <p:extLst>
      <p:ext uri="{BB962C8B-B14F-4D97-AF65-F5344CB8AC3E}">
        <p14:creationId xmlns:p14="http://schemas.microsoft.com/office/powerpoint/2010/main" val="1417498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107719" rtl="0" eaLnBrk="1" latinLnBrk="0" hangingPunct="1">
        <a:spcBef>
          <a:spcPct val="0"/>
        </a:spcBef>
        <a:buNone/>
        <a:defRPr sz="5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15396" indent="-415396" algn="l" defTabSz="1107719" rtl="0" eaLnBrk="1" latinLnBrk="0" hangingPunct="1">
        <a:spcBef>
          <a:spcPct val="20000"/>
        </a:spcBef>
        <a:buFont typeface="Arial" panose="020B0604020202020204" pitchFamily="34" charset="0"/>
        <a:buChar char="•"/>
        <a:defRPr sz="3800" kern="1200">
          <a:solidFill>
            <a:schemeClr val="tx1"/>
          </a:solidFill>
          <a:latin typeface="+mn-lt"/>
          <a:ea typeface="+mn-ea"/>
          <a:cs typeface="+mn-cs"/>
        </a:defRPr>
      </a:lvl1pPr>
      <a:lvl2pPr marL="900023" indent="-346163" algn="l" defTabSz="1107719" rtl="0" eaLnBrk="1" latinLnBrk="0" hangingPunct="1">
        <a:spcBef>
          <a:spcPct val="20000"/>
        </a:spcBef>
        <a:buFont typeface="Arial" panose="020B0604020202020204" pitchFamily="34" charset="0"/>
        <a:buChar char="–"/>
        <a:defRPr sz="3400" kern="1200">
          <a:solidFill>
            <a:schemeClr val="tx1"/>
          </a:solidFill>
          <a:latin typeface="+mn-lt"/>
          <a:ea typeface="+mn-ea"/>
          <a:cs typeface="+mn-cs"/>
        </a:defRPr>
      </a:lvl2pPr>
      <a:lvl3pPr marL="1384650" indent="-276930" algn="l" defTabSz="1107719" rtl="0" eaLnBrk="1" latinLnBrk="0" hangingPunct="1">
        <a:spcBef>
          <a:spcPct val="20000"/>
        </a:spcBef>
        <a:buFont typeface="Arial" panose="020B0604020202020204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3pPr>
      <a:lvl4pPr marL="1938509" indent="-276930" algn="l" defTabSz="1107719" rtl="0" eaLnBrk="1" latinLnBrk="0" hangingPunct="1">
        <a:spcBef>
          <a:spcPct val="20000"/>
        </a:spcBef>
        <a:buFont typeface="Arial" panose="020B0604020202020204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92370" indent="-276930" algn="l" defTabSz="1107719" rtl="0" eaLnBrk="1" latinLnBrk="0" hangingPunct="1">
        <a:spcBef>
          <a:spcPct val="20000"/>
        </a:spcBef>
        <a:buFont typeface="Arial" panose="020B0604020202020204" pitchFamily="34" charset="0"/>
        <a:buChar char="»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6230" indent="-276930" algn="l" defTabSz="1107719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00089" indent="-276930" algn="l" defTabSz="1107719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153949" indent="-276930" algn="l" defTabSz="1107719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707810" indent="-276930" algn="l" defTabSz="1107719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MX"/>
      </a:defPPr>
      <a:lvl1pPr marL="0" algn="l" defTabSz="1107719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1pPr>
      <a:lvl2pPr marL="553860" algn="l" defTabSz="1107719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2pPr>
      <a:lvl3pPr marL="1107719" algn="l" defTabSz="1107719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661580" algn="l" defTabSz="1107719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4pPr>
      <a:lvl5pPr marL="2215440" algn="l" defTabSz="1107719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5pPr>
      <a:lvl6pPr marL="2769299" algn="l" defTabSz="1107719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6pPr>
      <a:lvl7pPr marL="3323159" algn="l" defTabSz="1107719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7pPr>
      <a:lvl8pPr marL="3877020" algn="l" defTabSz="1107719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8pPr>
      <a:lvl9pPr marL="4430879" algn="l" defTabSz="1107719" rtl="0" eaLnBrk="1" latinLnBrk="0" hangingPunct="1">
        <a:defRPr sz="2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5" name="2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08373176"/>
              </p:ext>
            </p:extLst>
          </p:nvPr>
        </p:nvGraphicFramePr>
        <p:xfrm>
          <a:off x="792163" y="717461"/>
          <a:ext cx="4788024" cy="29576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2" name="1 CuadroTexto"/>
          <p:cNvSpPr txBox="1"/>
          <p:nvPr/>
        </p:nvSpPr>
        <p:spPr>
          <a:xfrm>
            <a:off x="5289922" y="219333"/>
            <a:ext cx="830833" cy="561182"/>
          </a:xfrm>
          <a:prstGeom prst="rect">
            <a:avLst/>
          </a:prstGeom>
          <a:noFill/>
        </p:spPr>
        <p:txBody>
          <a:bodyPr wrap="square" lIns="106317" tIns="53159" rIns="106317" bIns="53159" rtlCol="0">
            <a:spAutoFit/>
          </a:bodyPr>
          <a:lstStyle/>
          <a:p>
            <a:r>
              <a:rPr lang="es-MX" sz="29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2 CuadroTexto"/>
          <p:cNvSpPr txBox="1"/>
          <p:nvPr/>
        </p:nvSpPr>
        <p:spPr>
          <a:xfrm>
            <a:off x="5280397" y="3672458"/>
            <a:ext cx="830833" cy="561182"/>
          </a:xfrm>
          <a:prstGeom prst="rect">
            <a:avLst/>
          </a:prstGeom>
          <a:noFill/>
        </p:spPr>
        <p:txBody>
          <a:bodyPr wrap="square" lIns="106317" tIns="53159" rIns="106317" bIns="53159" rtlCol="0">
            <a:spAutoFit/>
          </a:bodyPr>
          <a:lstStyle/>
          <a:p>
            <a:r>
              <a:rPr lang="es-MX" sz="29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4" name="3 CuadroTexto"/>
          <p:cNvSpPr txBox="1"/>
          <p:nvPr/>
        </p:nvSpPr>
        <p:spPr>
          <a:xfrm>
            <a:off x="10186466" y="219333"/>
            <a:ext cx="830833" cy="553632"/>
          </a:xfrm>
          <a:prstGeom prst="rect">
            <a:avLst/>
          </a:prstGeom>
          <a:noFill/>
        </p:spPr>
        <p:txBody>
          <a:bodyPr wrap="square" lIns="106317" tIns="53159" rIns="106317" bIns="53159" rtlCol="0">
            <a:spAutoFit/>
          </a:bodyPr>
          <a:lstStyle/>
          <a:p>
            <a:r>
              <a:rPr lang="es-MX" sz="2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9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86102531"/>
              </p:ext>
            </p:extLst>
          </p:nvPr>
        </p:nvGraphicFramePr>
        <p:xfrm>
          <a:off x="737978" y="3960490"/>
          <a:ext cx="4713311" cy="30312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6" name="15 Rectángulo"/>
          <p:cNvSpPr/>
          <p:nvPr/>
        </p:nvSpPr>
        <p:spPr>
          <a:xfrm>
            <a:off x="6712215" y="4899981"/>
            <a:ext cx="144016" cy="14401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7" name="16 Rectángulo"/>
          <p:cNvSpPr/>
          <p:nvPr/>
        </p:nvSpPr>
        <p:spPr>
          <a:xfrm>
            <a:off x="6713753" y="5182376"/>
            <a:ext cx="144016" cy="144016"/>
          </a:xfrm>
          <a:prstGeom prst="rect">
            <a:avLst/>
          </a:prstGeom>
          <a:solidFill>
            <a:schemeClr val="bg1">
              <a:lumMod val="65000"/>
            </a:schemeClr>
          </a:solidFill>
          <a:ln>
            <a:solidFill>
              <a:schemeClr val="bg1">
                <a:lumMod val="6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MX"/>
          </a:p>
        </p:txBody>
      </p:sp>
      <p:sp>
        <p:nvSpPr>
          <p:cNvPr id="18" name="17 CuadroTexto"/>
          <p:cNvSpPr txBox="1"/>
          <p:nvPr/>
        </p:nvSpPr>
        <p:spPr>
          <a:xfrm>
            <a:off x="6839297" y="4802852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LB+DMSO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18 CuadroTexto"/>
          <p:cNvSpPr txBox="1"/>
          <p:nvPr/>
        </p:nvSpPr>
        <p:spPr>
          <a:xfrm>
            <a:off x="6840835" y="5083864"/>
            <a:ext cx="165618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MX" sz="16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B+Curcumin</a:t>
            </a:r>
            <a:endParaRPr lang="es-MX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0" name="1 Gráfico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58426598"/>
              </p:ext>
            </p:extLst>
          </p:nvPr>
        </p:nvGraphicFramePr>
        <p:xfrm>
          <a:off x="5695813" y="496149"/>
          <a:ext cx="4769431" cy="31043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20635571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50</TotalTime>
  <Words>10</Words>
  <Application>Microsoft Office PowerPoint</Application>
  <PresentationFormat>Personalizado</PresentationFormat>
  <Paragraphs>8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Company>Hewlett-Packard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iguel Angel Diaz Guerrero</dc:creator>
  <cp:lastModifiedBy>Miguel Angel Diaz Guerrero</cp:lastModifiedBy>
  <cp:revision>16</cp:revision>
  <dcterms:created xsi:type="dcterms:W3CDTF">2023-11-30T04:11:50Z</dcterms:created>
  <dcterms:modified xsi:type="dcterms:W3CDTF">2023-12-18T20:09:19Z</dcterms:modified>
</cp:coreProperties>
</file>